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144000" type="screen4x3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5758FB7-9AC5-4552-8A53-C91805E547FA}" styleName="Style à thème 1 - Accentuation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522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9570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4877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8751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8479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2659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2122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4082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435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6146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3542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114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3686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9802771"/>
              </p:ext>
            </p:extLst>
          </p:nvPr>
        </p:nvGraphicFramePr>
        <p:xfrm>
          <a:off x="77118" y="539841"/>
          <a:ext cx="6687239" cy="6295520"/>
        </p:xfrm>
        <a:graphic>
          <a:graphicData uri="http://schemas.openxmlformats.org/drawingml/2006/table">
            <a:tbl>
              <a:tblPr/>
              <a:tblGrid>
                <a:gridCol w="1285177">
                  <a:extLst>
                    <a:ext uri="{9D8B030D-6E8A-4147-A177-3AD203B41FA5}">
                      <a16:colId xmlns:a16="http://schemas.microsoft.com/office/drawing/2014/main" val="1895575169"/>
                    </a:ext>
                  </a:extLst>
                </a:gridCol>
                <a:gridCol w="2944399">
                  <a:extLst>
                    <a:ext uri="{9D8B030D-6E8A-4147-A177-3AD203B41FA5}">
                      <a16:colId xmlns:a16="http://schemas.microsoft.com/office/drawing/2014/main" val="1186357945"/>
                    </a:ext>
                  </a:extLst>
                </a:gridCol>
                <a:gridCol w="251760">
                  <a:extLst>
                    <a:ext uri="{9D8B030D-6E8A-4147-A177-3AD203B41FA5}">
                      <a16:colId xmlns:a16="http://schemas.microsoft.com/office/drawing/2014/main" val="3042375428"/>
                    </a:ext>
                  </a:extLst>
                </a:gridCol>
                <a:gridCol w="153455">
                  <a:extLst>
                    <a:ext uri="{9D8B030D-6E8A-4147-A177-3AD203B41FA5}">
                      <a16:colId xmlns:a16="http://schemas.microsoft.com/office/drawing/2014/main" val="4139458394"/>
                    </a:ext>
                  </a:extLst>
                </a:gridCol>
                <a:gridCol w="604225">
                  <a:extLst>
                    <a:ext uri="{9D8B030D-6E8A-4147-A177-3AD203B41FA5}">
                      <a16:colId xmlns:a16="http://schemas.microsoft.com/office/drawing/2014/main" val="2325868563"/>
                    </a:ext>
                  </a:extLst>
                </a:gridCol>
                <a:gridCol w="604225">
                  <a:extLst>
                    <a:ext uri="{9D8B030D-6E8A-4147-A177-3AD203B41FA5}">
                      <a16:colId xmlns:a16="http://schemas.microsoft.com/office/drawing/2014/main" val="2345104563"/>
                    </a:ext>
                  </a:extLst>
                </a:gridCol>
                <a:gridCol w="421999">
                  <a:extLst>
                    <a:ext uri="{9D8B030D-6E8A-4147-A177-3AD203B41FA5}">
                      <a16:colId xmlns:a16="http://schemas.microsoft.com/office/drawing/2014/main" val="3494392401"/>
                    </a:ext>
                  </a:extLst>
                </a:gridCol>
                <a:gridCol w="421999">
                  <a:extLst>
                    <a:ext uri="{9D8B030D-6E8A-4147-A177-3AD203B41FA5}">
                      <a16:colId xmlns:a16="http://schemas.microsoft.com/office/drawing/2014/main" val="2126465729"/>
                    </a:ext>
                  </a:extLst>
                </a:gridCol>
              </a:tblGrid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crip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Value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6636426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cycle - Mus musculus (mouse)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303128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1940133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0E-0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56115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GG_pathway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caine addiction - Mus musculus (mouse)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17152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585365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0E-0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8992262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1392294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crip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Value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7832287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cellular region part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1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71503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6974507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0E-0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3328334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cellular reg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2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032279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9484643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0E-0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7007420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cellular space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3791979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8023690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0E-0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6708765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cellular exosome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5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369416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2461315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9678823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cellular organelle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5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760678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1746465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2538397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Cellular-Component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cellular vesicle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5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760678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1746465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490212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9902218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crip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Value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717519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ed 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732612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918421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0E-0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7492122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tassium 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638330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1071428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0E-0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1038874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ion 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051004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658227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0E-0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3244564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tassium ion transmembrane transporter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457496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404761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2278823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on 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00772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3454545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4777324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bstrate-specific 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780525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603603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7030796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organic cation transmembrane transporter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687789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3694581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751218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508500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8595041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8760355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ssive transmembrane transporter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508500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8595041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6789242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oltage-gated ion 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639876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9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0011248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oltage-gated 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639876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9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8979651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lcium activated cation 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27357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3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0E-0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3544743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al ion transmembrane transporter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8964451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2411347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4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2023761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ion transmembrane transporter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1653786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9596774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80E-0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3221903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membrane transporter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2936630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3112244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0E-0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4883081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oltage-gated potassium 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591962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8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0E-0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5767609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on gated channel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591962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88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0E-0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7459296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on transmembrane transporter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4250386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3313069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0E-0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9222604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bstrate-specific transmembrane transporter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5888717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246498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0E-0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0001473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novalent inorganic cation transmembrane transporter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5996909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11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0E-0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3639423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porter activity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5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57187017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5771428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0E-0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2896832"/>
                  </a:ext>
                </a:extLst>
              </a:tr>
              <a:tr h="179872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-Molecular_Function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aluronic acid binding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636785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13333333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70E-04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80E-02</a:t>
                      </a:r>
                    </a:p>
                  </a:txBody>
                  <a:tcPr marL="6365" marR="6365" marT="63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3124308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327752" y="7196600"/>
            <a:ext cx="6202496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100" b="1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S4</a:t>
            </a:r>
            <a:r>
              <a:rPr lang="en-GB" sz="11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 Table. </a:t>
            </a:r>
            <a:r>
              <a:rPr lang="en-GB" sz="11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Gene ontology from differential gene expression analysis of </a:t>
            </a:r>
            <a:r>
              <a:rPr lang="en-GB" sz="1100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RNAseq</a:t>
            </a:r>
            <a:r>
              <a:rPr lang="en-GB" sz="11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 data for Cherry+ beta cells in HFD </a:t>
            </a:r>
            <a:r>
              <a:rPr lang="en-GB" sz="11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mice. 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</a:rPr>
              <a:t>Differentially expressed genes for Cherry+ beta cells between HFD and LFD mice (</a:t>
            </a:r>
            <a:r>
              <a:rPr lang="en-GB" sz="11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EdgeR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</a:rPr>
              <a:t> method) were analysed for GO enrichment and KEGG pathway analysis using </a:t>
            </a:r>
            <a:r>
              <a:rPr lang="en-GB" sz="11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WebGestalt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</a:rPr>
              <a:t> 2017 software.</a:t>
            </a:r>
            <a:endParaRPr lang="fr-FR" sz="1100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36535764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99</TotalTime>
  <Words>398</Words>
  <Application>Microsoft Office PowerPoint</Application>
  <PresentationFormat>Affichage à l'écran (4:3)</PresentationFormat>
  <Paragraphs>26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Uni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van Gosmain</dc:creator>
  <cp:lastModifiedBy>Rodolphe Dusaulcy</cp:lastModifiedBy>
  <cp:revision>181</cp:revision>
  <cp:lastPrinted>2018-10-26T15:14:21Z</cp:lastPrinted>
  <dcterms:created xsi:type="dcterms:W3CDTF">2018-03-28T11:59:25Z</dcterms:created>
  <dcterms:modified xsi:type="dcterms:W3CDTF">2019-01-21T16:01:02Z</dcterms:modified>
</cp:coreProperties>
</file>